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56" r:id="rId2"/>
    <p:sldId id="347" r:id="rId3"/>
    <p:sldId id="3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2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昂 李" initials="昂李" lastIdx="1" clrIdx="0">
    <p:extLst>
      <p:ext uri="{19B8F6BF-5375-455C-9EA6-DF929625EA0E}">
        <p15:presenceInfo xmlns:p15="http://schemas.microsoft.com/office/powerpoint/2012/main" userId="6247aac55bd6f68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F0000"/>
    <a:srgbClr val="0033CC"/>
    <a:srgbClr val="EDFF09"/>
    <a:srgbClr val="8BD14B"/>
    <a:srgbClr val="BAD8FB"/>
    <a:srgbClr val="A6EFF8"/>
    <a:srgbClr val="BDE4EF"/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度样式 2 - 强调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00" autoAdjust="0"/>
    <p:restoredTop sz="95184" autoAdjust="0"/>
  </p:normalViewPr>
  <p:slideViewPr>
    <p:cSldViewPr snapToGrid="0">
      <p:cViewPr varScale="1">
        <p:scale>
          <a:sx n="79" d="100"/>
          <a:sy n="79" d="100"/>
        </p:scale>
        <p:origin x="3252" y="96"/>
      </p:cViewPr>
      <p:guideLst>
        <p:guide orient="horz" pos="3324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6" d="100"/>
          <a:sy n="86" d="100"/>
        </p:scale>
        <p:origin x="3864" y="90"/>
      </p:cViewPr>
      <p:guideLst/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5040BF-8E9A-46AF-8678-C98AF97C7572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E968FB-A44B-4239-9D57-F4E202BE28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482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444B89-401E-16F9-BD73-3CFA756CEAE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B4D6C381-78D8-1C49-AB08-9AA191B67B5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1CB5B62E-05E3-FA27-6C50-3BA1150661C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54CBDE6-A3A0-221A-6504-903C3905B02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E968FB-A44B-4239-9D57-F4E202BE28DD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905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8023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97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AE08E6C2-1B0C-6DEC-9D5F-DCB4843D492E}"/>
              </a:ext>
            </a:extLst>
          </p:cNvPr>
          <p:cNvSpPr/>
          <p:nvPr userDrawn="1"/>
        </p:nvSpPr>
        <p:spPr>
          <a:xfrm>
            <a:off x="471487" y="471599"/>
            <a:ext cx="5915024" cy="8906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224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255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0900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4509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7523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418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264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5911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3088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E1E6C-108A-4A2E-9C51-96B0A77D65C5}" type="datetimeFigureOut">
              <a:rPr lang="zh-CN" altLang="en-US" smtClean="0"/>
              <a:t>2026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9FD36-5AC5-43DF-9C9C-2F2FC9A56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336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306119B-0DDD-C17A-ECEC-7C574F637C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>
            <a:extLst>
              <a:ext uri="{FF2B5EF4-FFF2-40B4-BE49-F238E27FC236}">
                <a16:creationId xmlns:a16="http://schemas.microsoft.com/office/drawing/2014/main" id="{0D1680FD-BBBB-8B0E-D7CD-68F44E915ED1}"/>
              </a:ext>
            </a:extLst>
          </p:cNvPr>
          <p:cNvSpPr txBox="1"/>
          <p:nvPr/>
        </p:nvSpPr>
        <p:spPr>
          <a:xfrm>
            <a:off x="477455" y="474887"/>
            <a:ext cx="236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FFFFFF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solidFill>
                <a:srgbClr val="FFFFFF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A59EBB7-BB19-73CB-4381-BD13A4606BDB}"/>
              </a:ext>
            </a:extLst>
          </p:cNvPr>
          <p:cNvSpPr txBox="1"/>
          <p:nvPr/>
        </p:nvSpPr>
        <p:spPr>
          <a:xfrm>
            <a:off x="482917" y="5762669"/>
            <a:ext cx="59004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zh-CN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Fig</a:t>
            </a:r>
            <a:r>
              <a:rPr lang="en-US" altLang="zh-CN" sz="1200" b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r>
              <a:rPr lang="en-US" altLang="zh-CN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S1 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issue specific expression patterns of SlbHLH70. Data are Illumina-derived and RPKM-normalized. These images were generated with the Plant eFP at bar.utoronto.ca/eplant as described by by Waese et al. (2017).</a:t>
            </a:r>
            <a:endParaRPr lang="zh-CN" alt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12943AA6-116D-FE10-7C46-CCC9AFBCA42E}"/>
              </a:ext>
            </a:extLst>
          </p:cNvPr>
          <p:cNvGrpSpPr/>
          <p:nvPr/>
        </p:nvGrpSpPr>
        <p:grpSpPr>
          <a:xfrm>
            <a:off x="731829" y="682669"/>
            <a:ext cx="5651532" cy="5053888"/>
            <a:chOff x="731829" y="619169"/>
            <a:chExt cx="5651532" cy="5053888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9BD9ACCB-B1B4-3DFE-2C2D-C6A688504C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6"/>
            <a:stretch/>
          </p:blipFill>
          <p:spPr>
            <a:xfrm>
              <a:off x="731829" y="855756"/>
              <a:ext cx="5394342" cy="4817301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0A8165E-8BC9-FC04-1266-3DFF26B7D1A7}"/>
                </a:ext>
              </a:extLst>
            </p:cNvPr>
            <p:cNvSpPr txBox="1"/>
            <p:nvPr/>
          </p:nvSpPr>
          <p:spPr>
            <a:xfrm>
              <a:off x="815953" y="619169"/>
              <a:ext cx="55645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atinLnBrk="1"/>
              <a:r>
                <a:rPr lang="en-US" altLang="zh-CN" sz="1200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lant eFP: Solyc12g010170</a:t>
              </a:r>
              <a:endParaRPr lang="zh-CN" altLang="zh-CN" sz="12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FAC2DEE-6B0D-0BF1-5438-D9783F09A612}"/>
                </a:ext>
              </a:extLst>
            </p:cNvPr>
            <p:cNvSpPr txBox="1"/>
            <p:nvPr/>
          </p:nvSpPr>
          <p:spPr>
            <a:xfrm>
              <a:off x="815953" y="885486"/>
              <a:ext cx="55674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atinLnBrk="1"/>
              <a:r>
                <a:rPr lang="en-US" altLang="zh-CN" sz="1400" b="1" i="1">
                  <a:effectLst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lbHLH70</a:t>
              </a:r>
              <a:endParaRPr lang="zh-CN" altLang="zh-CN" sz="1400" b="1" i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465011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1648FC-BEA1-DBF3-8005-5379066F4E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7AB7251-7A56-B499-6C9D-A38E20876E7A}"/>
              </a:ext>
            </a:extLst>
          </p:cNvPr>
          <p:cNvSpPr txBox="1"/>
          <p:nvPr/>
        </p:nvSpPr>
        <p:spPr>
          <a:xfrm>
            <a:off x="671889" y="2534082"/>
            <a:ext cx="14766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28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 ck-A1 ck</a:t>
            </a:r>
            <a:endParaRPr lang="zh-CN" altLang="en-US" sz="12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85A0DFB-4C53-40C6-E570-506F5AD588A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4407"/>
          <a:stretch/>
        </p:blipFill>
        <p:spPr>
          <a:xfrm>
            <a:off x="504825" y="660344"/>
            <a:ext cx="1810800" cy="183819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CFF552E-11B0-B98E-F46C-EB993290914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201"/>
          <a:stretch/>
        </p:blipFill>
        <p:spPr>
          <a:xfrm>
            <a:off x="2375518" y="660344"/>
            <a:ext cx="1810800" cy="185735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1787CB7-A715-8CA3-4E02-03DA6B4109EB}"/>
              </a:ext>
            </a:extLst>
          </p:cNvPr>
          <p:cNvSpPr txBox="1"/>
          <p:nvPr/>
        </p:nvSpPr>
        <p:spPr>
          <a:xfrm>
            <a:off x="2246720" y="2534082"/>
            <a:ext cx="206839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28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 drought-A1 drought</a:t>
            </a:r>
            <a:endParaRPr lang="zh-CN" altLang="en-US" sz="1200" b="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796868-AB3B-18DF-B430-6072681B353B}"/>
              </a:ext>
            </a:extLst>
          </p:cNvPr>
          <p:cNvSpPr txBox="1"/>
          <p:nvPr/>
        </p:nvSpPr>
        <p:spPr>
          <a:xfrm>
            <a:off x="471104" y="3048664"/>
            <a:ext cx="591579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2</a:t>
            </a:r>
            <a:r>
              <a:rPr lang="en-US" altLang="zh-CN" sz="12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dentification of drought-responsive genes directly regulated by SlbHLH70. </a:t>
            </a:r>
          </a:p>
          <a:p>
            <a:r>
              <a:rPr lang="en-US" altLang="zh-CN" sz="12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-B) Volcano plot of differentially expressed genes (DEG) in SlbHLH70 knockout line (KO4) and wild-type (WT) plants under normal water (A) and drought stress (B) conditions (| log FC | ≥ 2, padj ≤ 0.01). The red/blue dots represent up/down-regulated genes. (C) Comprehensive analysis of DAP-seq peaks and RNA-seq data. 164 genes with a SlbHLH70 binding promoter and drought response expression that differ before and after knockout of the SlbHLH70 gene are highlighted. Venn diagram. "AD-AW" indicates DEGs between drought-stressed and normally watered plants; "BD-BW" indicates DEGs between drought-stressed and normally watered plants; "DAP-seq", a potential target gene from DAP-seq. 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B1F25AC-16FC-5657-F03C-58472ACA02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96329" y="660343"/>
            <a:ext cx="1993263" cy="19440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459A89B-BC5D-A1FC-9433-8346DA7C47DE}"/>
              </a:ext>
            </a:extLst>
          </p:cNvPr>
          <p:cNvSpPr txBox="1"/>
          <p:nvPr/>
        </p:nvSpPr>
        <p:spPr>
          <a:xfrm>
            <a:off x="477455" y="474875"/>
            <a:ext cx="236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96BC5F2-D64A-F0F5-7A98-BECDD9FD8BF1}"/>
              </a:ext>
            </a:extLst>
          </p:cNvPr>
          <p:cNvSpPr txBox="1"/>
          <p:nvPr/>
        </p:nvSpPr>
        <p:spPr>
          <a:xfrm>
            <a:off x="2358649" y="474875"/>
            <a:ext cx="236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D1721A4-5DB3-E386-914B-9A10D35E2C88}"/>
              </a:ext>
            </a:extLst>
          </p:cNvPr>
          <p:cNvSpPr txBox="1"/>
          <p:nvPr/>
        </p:nvSpPr>
        <p:spPr>
          <a:xfrm>
            <a:off x="4250173" y="474875"/>
            <a:ext cx="236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157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959314-D39D-832A-1592-D58B9B1CB3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文本框 270">
            <a:extLst>
              <a:ext uri="{FF2B5EF4-FFF2-40B4-BE49-F238E27FC236}">
                <a16:creationId xmlns:a16="http://schemas.microsoft.com/office/drawing/2014/main" id="{AFCC73DD-3A14-AE82-CB9D-36ED16112A68}"/>
              </a:ext>
            </a:extLst>
          </p:cNvPr>
          <p:cNvSpPr txBox="1"/>
          <p:nvPr/>
        </p:nvSpPr>
        <p:spPr>
          <a:xfrm>
            <a:off x="469900" y="4729552"/>
            <a:ext cx="5915791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>
              <a:lnSpc>
                <a:spcPts val="1440"/>
              </a:lnSpc>
            </a:pPr>
            <a:r>
              <a:rPr lang="en-US" altLang="zh-CN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宋体" panose="02010600030101010101" pitchFamily="2" charset="-122"/>
              </a:rPr>
              <a:t>Fig. S3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</a:t>
            </a:r>
            <a:r>
              <a:rPr lang="en-US" altLang="zh-CN" sz="12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,</a:t>
            </a:r>
            <a:r>
              <a:rPr lang="en-US" altLang="zh-CN" sz="12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B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 Stomatal aperture measurements in WT and transgenic plants. No significant differences observed (P &gt; 0.05). (C</a:t>
            </a:r>
            <a:r>
              <a:rPr lang="en-US" altLang="zh-CN" sz="12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</a:t>
            </a:r>
            <a:r>
              <a:rPr lang="en-US" altLang="zh-CN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Water loss rates of detached leaves from WT, OE, and KO plants.  </a:t>
            </a:r>
            <a:endParaRPr lang="zh-CN" alt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8952B94-F5D2-C54C-3802-8257F3BE897F}"/>
              </a:ext>
            </a:extLst>
          </p:cNvPr>
          <p:cNvSpPr txBox="1"/>
          <p:nvPr/>
        </p:nvSpPr>
        <p:spPr>
          <a:xfrm>
            <a:off x="477885" y="477216"/>
            <a:ext cx="236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370341F-B846-1241-DF32-08B8686752F8}"/>
              </a:ext>
            </a:extLst>
          </p:cNvPr>
          <p:cNvSpPr txBox="1"/>
          <p:nvPr/>
        </p:nvSpPr>
        <p:spPr>
          <a:xfrm>
            <a:off x="3345539" y="477216"/>
            <a:ext cx="236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4E6C9E09-43BA-CE8E-30F0-2EA27A7A7717}"/>
              </a:ext>
            </a:extLst>
          </p:cNvPr>
          <p:cNvGrpSpPr/>
          <p:nvPr/>
        </p:nvGrpSpPr>
        <p:grpSpPr>
          <a:xfrm>
            <a:off x="779131" y="737277"/>
            <a:ext cx="2465719" cy="1632279"/>
            <a:chOff x="3876114" y="4121152"/>
            <a:chExt cx="2740682" cy="181430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0468E31-66DD-18E6-A736-5B29E87997B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76114" y="4121152"/>
              <a:ext cx="2408129" cy="163387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1947285-E406-1000-744C-E7D1F0136114}"/>
                </a:ext>
              </a:extLst>
            </p:cNvPr>
            <p:cNvSpPr txBox="1"/>
            <p:nvPr/>
          </p:nvSpPr>
          <p:spPr>
            <a:xfrm>
              <a:off x="3987764" y="5732337"/>
              <a:ext cx="538853" cy="203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7985E77-9554-62BC-A741-8804463D11DE}"/>
                </a:ext>
              </a:extLst>
            </p:cNvPr>
            <p:cNvSpPr txBox="1"/>
            <p:nvPr/>
          </p:nvSpPr>
          <p:spPr>
            <a:xfrm>
              <a:off x="4808875" y="5732337"/>
              <a:ext cx="538853" cy="203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2843DE6-01A1-8DED-E217-58C8895ED587}"/>
                </a:ext>
              </a:extLst>
            </p:cNvPr>
            <p:cNvSpPr txBox="1"/>
            <p:nvPr/>
          </p:nvSpPr>
          <p:spPr>
            <a:xfrm>
              <a:off x="5624119" y="5732337"/>
              <a:ext cx="538853" cy="203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4E30B5A-538E-3085-E05D-82CDD3A0CE05}"/>
                </a:ext>
              </a:extLst>
            </p:cNvPr>
            <p:cNvSpPr txBox="1"/>
            <p:nvPr/>
          </p:nvSpPr>
          <p:spPr>
            <a:xfrm>
              <a:off x="6214835" y="4356339"/>
              <a:ext cx="4019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K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19EC430-EEC5-756F-3ACE-DD3AC5251EE9}"/>
                </a:ext>
              </a:extLst>
            </p:cNvPr>
            <p:cNvSpPr txBox="1"/>
            <p:nvPr/>
          </p:nvSpPr>
          <p:spPr>
            <a:xfrm>
              <a:off x="6214835" y="5223578"/>
              <a:ext cx="4019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S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5" name="图片 14">
            <a:extLst>
              <a:ext uri="{FF2B5EF4-FFF2-40B4-BE49-F238E27FC236}">
                <a16:creationId xmlns:a16="http://schemas.microsoft.com/office/drawing/2014/main" id="{53F1D0B8-162E-A623-9F58-AA152276741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12"/>
          <a:stretch/>
        </p:blipFill>
        <p:spPr>
          <a:xfrm>
            <a:off x="639341" y="2557887"/>
            <a:ext cx="2605509" cy="2087058"/>
          </a:xfrm>
          <a:prstGeom prst="rect">
            <a:avLst/>
          </a:prstGeom>
        </p:spPr>
      </p:pic>
      <p:grpSp>
        <p:nvGrpSpPr>
          <p:cNvPr id="16" name="组合 15">
            <a:extLst>
              <a:ext uri="{FF2B5EF4-FFF2-40B4-BE49-F238E27FC236}">
                <a16:creationId xmlns:a16="http://schemas.microsoft.com/office/drawing/2014/main" id="{4113AEF4-4A5D-7FE5-443E-56ADAA0E119B}"/>
              </a:ext>
            </a:extLst>
          </p:cNvPr>
          <p:cNvGrpSpPr/>
          <p:nvPr/>
        </p:nvGrpSpPr>
        <p:grpSpPr>
          <a:xfrm>
            <a:off x="3442286" y="615715"/>
            <a:ext cx="2794021" cy="1828386"/>
            <a:chOff x="3159870" y="1985231"/>
            <a:chExt cx="3069580" cy="2008709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DD3C1713-C1B5-E403-4B46-8570A41B31FE}"/>
                </a:ext>
              </a:extLst>
            </p:cNvPr>
            <p:cNvGrpSpPr/>
            <p:nvPr/>
          </p:nvGrpSpPr>
          <p:grpSpPr>
            <a:xfrm>
              <a:off x="3159870" y="1985231"/>
              <a:ext cx="3069580" cy="1836000"/>
              <a:chOff x="3489784" y="2003488"/>
              <a:chExt cx="3069580" cy="1836000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476E7997-77F4-785F-C11B-1F3FAB3087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89784" y="2003488"/>
                <a:ext cx="3069580" cy="1836000"/>
              </a:xfrm>
              <a:prstGeom prst="rect">
                <a:avLst/>
              </a:prstGeom>
            </p:spPr>
          </p:pic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543A48F6-C99C-9F2C-847D-AD6FEFB9B71C}"/>
                  </a:ext>
                </a:extLst>
              </p:cNvPr>
              <p:cNvSpPr/>
              <p:nvPr/>
            </p:nvSpPr>
            <p:spPr>
              <a:xfrm>
                <a:off x="5190660" y="3529446"/>
                <a:ext cx="138419" cy="20754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69D596E6-10CF-DBE5-4605-09D01B2C30D1}"/>
                </a:ext>
              </a:extLst>
            </p:cNvPr>
            <p:cNvGrpSpPr/>
            <p:nvPr/>
          </p:nvGrpSpPr>
          <p:grpSpPr>
            <a:xfrm>
              <a:off x="3851497" y="3757566"/>
              <a:ext cx="2234023" cy="236374"/>
              <a:chOff x="726281" y="3757566"/>
              <a:chExt cx="2234023" cy="236374"/>
            </a:xfrm>
          </p:grpSpPr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8AADFC67-0A60-42EC-B5A9-55191D3C09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6281" y="3757566"/>
                <a:ext cx="98582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7FB71B4D-F6D5-84BA-EE5F-F258AA47F2F9}"/>
                  </a:ext>
                </a:extLst>
              </p:cNvPr>
              <p:cNvSpPr txBox="1"/>
              <p:nvPr/>
            </p:nvSpPr>
            <p:spPr>
              <a:xfrm>
                <a:off x="941866" y="3765702"/>
                <a:ext cx="554655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5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zh-CN" altLang="en-US" sz="75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38596467-41D1-9D50-3CAF-3906A408F3B0}"/>
                  </a:ext>
                </a:extLst>
              </p:cNvPr>
              <p:cNvSpPr txBox="1"/>
              <p:nvPr/>
            </p:nvSpPr>
            <p:spPr>
              <a:xfrm>
                <a:off x="2082293" y="3765702"/>
                <a:ext cx="662425" cy="2282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5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rought</a:t>
                </a:r>
                <a:endParaRPr lang="zh-CN" altLang="en-US" sz="75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E9BDE2E2-0280-6F4A-E8D1-843D8F8479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74479" y="3757566"/>
                <a:ext cx="98582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" name="文本框 26">
            <a:extLst>
              <a:ext uri="{FF2B5EF4-FFF2-40B4-BE49-F238E27FC236}">
                <a16:creationId xmlns:a16="http://schemas.microsoft.com/office/drawing/2014/main" id="{899D73E6-B956-0972-433A-070774528A84}"/>
              </a:ext>
            </a:extLst>
          </p:cNvPr>
          <p:cNvSpPr txBox="1"/>
          <p:nvPr/>
        </p:nvSpPr>
        <p:spPr>
          <a:xfrm>
            <a:off x="477885" y="2386391"/>
            <a:ext cx="236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347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6646</TotalTime>
  <Words>258</Words>
  <Application>Microsoft Office PowerPoint</Application>
  <PresentationFormat>A4 纸张(210x297 毫米)</PresentationFormat>
  <Paragraphs>23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昂 李</dc:creator>
  <cp:lastModifiedBy>昂 李</cp:lastModifiedBy>
  <cp:revision>295</cp:revision>
  <dcterms:created xsi:type="dcterms:W3CDTF">2024-06-09T17:55:30Z</dcterms:created>
  <dcterms:modified xsi:type="dcterms:W3CDTF">2026-01-30T05:40:56Z</dcterms:modified>
</cp:coreProperties>
</file>